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86407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CECE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79" autoAdjust="0"/>
    <p:restoredTop sz="94660"/>
  </p:normalViewPr>
  <p:slideViewPr>
    <p:cSldViewPr snapToGrid="0">
      <p:cViewPr>
        <p:scale>
          <a:sx n="25" d="100"/>
          <a:sy n="25" d="100"/>
        </p:scale>
        <p:origin x="27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8057" y="2945943"/>
            <a:ext cx="7344649" cy="6266897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096" y="9454516"/>
            <a:ext cx="6480572" cy="4345992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54" indent="0" algn="ctr">
              <a:buNone/>
              <a:defRPr sz="1890"/>
            </a:lvl2pPr>
            <a:lvl3pPr marL="864108" indent="0" algn="ctr">
              <a:buNone/>
              <a:defRPr sz="1701"/>
            </a:lvl3pPr>
            <a:lvl4pPr marL="1296162" indent="0" algn="ctr">
              <a:buNone/>
              <a:defRPr sz="1512"/>
            </a:lvl4pPr>
            <a:lvl5pPr marL="1728216" indent="0" algn="ctr">
              <a:buNone/>
              <a:defRPr sz="1512"/>
            </a:lvl5pPr>
            <a:lvl6pPr marL="2160270" indent="0" algn="ctr">
              <a:buNone/>
              <a:defRPr sz="1512"/>
            </a:lvl6pPr>
            <a:lvl7pPr marL="2592324" indent="0" algn="ctr">
              <a:buNone/>
              <a:defRPr sz="1512"/>
            </a:lvl7pPr>
            <a:lvl8pPr marL="3024378" indent="0" algn="ctr">
              <a:buNone/>
              <a:defRPr sz="1512"/>
            </a:lvl8pPr>
            <a:lvl9pPr marL="3456432" indent="0" algn="ctr">
              <a:buNone/>
              <a:defRPr sz="151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6500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7393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3546" y="958369"/>
            <a:ext cx="1863165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053" y="958369"/>
            <a:ext cx="5481484" cy="15254730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017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784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553" y="4487671"/>
            <a:ext cx="7452658" cy="7487774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553" y="12046282"/>
            <a:ext cx="7452658" cy="3937644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205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10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16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21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324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37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432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6059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053" y="4791843"/>
            <a:ext cx="3672324" cy="1142125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4386" y="4791843"/>
            <a:ext cx="3672324" cy="1142125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886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958373"/>
            <a:ext cx="7452658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179" y="4412664"/>
            <a:ext cx="3655447" cy="216257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179" y="6575242"/>
            <a:ext cx="3655447" cy="9671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4387" y="4412664"/>
            <a:ext cx="3673450" cy="2162578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54" indent="0">
              <a:buNone/>
              <a:defRPr sz="1890" b="1"/>
            </a:lvl2pPr>
            <a:lvl3pPr marL="864108" indent="0">
              <a:buNone/>
              <a:defRPr sz="1701" b="1"/>
            </a:lvl3pPr>
            <a:lvl4pPr marL="1296162" indent="0">
              <a:buNone/>
              <a:defRPr sz="1512" b="1"/>
            </a:lvl4pPr>
            <a:lvl5pPr marL="1728216" indent="0">
              <a:buNone/>
              <a:defRPr sz="1512" b="1"/>
            </a:lvl5pPr>
            <a:lvl6pPr marL="2160270" indent="0">
              <a:buNone/>
              <a:defRPr sz="1512" b="1"/>
            </a:lvl6pPr>
            <a:lvl7pPr marL="2592324" indent="0">
              <a:buNone/>
              <a:defRPr sz="1512" b="1"/>
            </a:lvl7pPr>
            <a:lvl8pPr marL="3024378" indent="0">
              <a:buNone/>
              <a:defRPr sz="1512" b="1"/>
            </a:lvl8pPr>
            <a:lvl9pPr marL="3456432" indent="0">
              <a:buNone/>
              <a:defRPr sz="1512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4387" y="6575242"/>
            <a:ext cx="3673450" cy="967119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834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931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359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1200044"/>
            <a:ext cx="2786871" cy="4200155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3450" y="2591766"/>
            <a:ext cx="4374386" cy="12792138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5400199"/>
            <a:ext cx="2786871" cy="10004536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2880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178" y="1200044"/>
            <a:ext cx="2786871" cy="4200155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3450" y="2591766"/>
            <a:ext cx="4374386" cy="12792138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54" indent="0">
              <a:buNone/>
              <a:defRPr sz="2646"/>
            </a:lvl2pPr>
            <a:lvl3pPr marL="864108" indent="0">
              <a:buNone/>
              <a:defRPr sz="2268"/>
            </a:lvl3pPr>
            <a:lvl4pPr marL="1296162" indent="0">
              <a:buNone/>
              <a:defRPr sz="1890"/>
            </a:lvl4pPr>
            <a:lvl5pPr marL="1728216" indent="0">
              <a:buNone/>
              <a:defRPr sz="1890"/>
            </a:lvl5pPr>
            <a:lvl6pPr marL="2160270" indent="0">
              <a:buNone/>
              <a:defRPr sz="1890"/>
            </a:lvl6pPr>
            <a:lvl7pPr marL="2592324" indent="0">
              <a:buNone/>
              <a:defRPr sz="1890"/>
            </a:lvl7pPr>
            <a:lvl8pPr marL="3024378" indent="0">
              <a:buNone/>
              <a:defRPr sz="1890"/>
            </a:lvl8pPr>
            <a:lvl9pPr marL="3456432" indent="0">
              <a:buNone/>
              <a:defRPr sz="189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178" y="5400199"/>
            <a:ext cx="2786871" cy="10004536"/>
          </a:xfrm>
        </p:spPr>
        <p:txBody>
          <a:bodyPr/>
          <a:lstStyle>
            <a:lvl1pPr marL="0" indent="0">
              <a:buNone/>
              <a:defRPr sz="1512"/>
            </a:lvl1pPr>
            <a:lvl2pPr marL="432054" indent="0">
              <a:buNone/>
              <a:defRPr sz="1323"/>
            </a:lvl2pPr>
            <a:lvl3pPr marL="864108" indent="0">
              <a:buNone/>
              <a:defRPr sz="1134"/>
            </a:lvl3pPr>
            <a:lvl4pPr marL="1296162" indent="0">
              <a:buNone/>
              <a:defRPr sz="945"/>
            </a:lvl4pPr>
            <a:lvl5pPr marL="1728216" indent="0">
              <a:buNone/>
              <a:defRPr sz="945"/>
            </a:lvl5pPr>
            <a:lvl6pPr marL="2160270" indent="0">
              <a:buNone/>
              <a:defRPr sz="945"/>
            </a:lvl6pPr>
            <a:lvl7pPr marL="2592324" indent="0">
              <a:buNone/>
              <a:defRPr sz="945"/>
            </a:lvl7pPr>
            <a:lvl8pPr marL="3024378" indent="0">
              <a:buNone/>
              <a:defRPr sz="945"/>
            </a:lvl8pPr>
            <a:lvl9pPr marL="3456432" indent="0">
              <a:buNone/>
              <a:defRPr sz="94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604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053" y="958373"/>
            <a:ext cx="7452658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053" y="4791843"/>
            <a:ext cx="7452658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052" y="16683952"/>
            <a:ext cx="19441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D342D-6296-4CF6-8645-696F4AF9ECAB}" type="datetimeFigureOut">
              <a:rPr lang="zh-CN" altLang="en-US" smtClean="0"/>
              <a:t>2018/4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2253" y="16683952"/>
            <a:ext cx="291625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2539" y="16683952"/>
            <a:ext cx="19441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10824-BEEA-4317-A03E-25EEB423DC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282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64108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27" indent="-216027" algn="l" defTabSz="864108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8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18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243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297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351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405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459" indent="-216027" algn="l" defTabSz="864108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5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10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16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216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324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378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432" algn="l" defTabSz="864108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27C1351-E86B-4CA3-9BAC-1E285D3186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7299" y="1157099"/>
            <a:ext cx="154647" cy="128325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0FF787A-F5AD-42A9-8826-B238A773BB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1333" y="1634319"/>
            <a:ext cx="139551" cy="53873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560D94A6-3160-4E5A-A7A4-29F5DBF21B1E}"/>
              </a:ext>
            </a:extLst>
          </p:cNvPr>
          <p:cNvSpPr txBox="1"/>
          <p:nvPr/>
        </p:nvSpPr>
        <p:spPr>
          <a:xfrm>
            <a:off x="6092615" y="1014472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38F3BDF-3BE6-44A3-AC17-AE4492E15770}"/>
              </a:ext>
            </a:extLst>
          </p:cNvPr>
          <p:cNvSpPr txBox="1"/>
          <p:nvPr/>
        </p:nvSpPr>
        <p:spPr>
          <a:xfrm>
            <a:off x="6087371" y="1434141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Mig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0076D59-22BE-43CC-9CE7-E4BD452DAB68}"/>
              </a:ext>
            </a:extLst>
          </p:cNvPr>
          <p:cNvSpPr txBox="1"/>
          <p:nvPr/>
        </p:nvSpPr>
        <p:spPr>
          <a:xfrm>
            <a:off x="6120200" y="2045601"/>
            <a:ext cx="130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Prolife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EF8F2DE-6155-4137-A63C-5B854C48A7E2}"/>
              </a:ext>
            </a:extLst>
          </p:cNvPr>
          <p:cNvSpPr txBox="1"/>
          <p:nvPr/>
        </p:nvSpPr>
        <p:spPr>
          <a:xfrm>
            <a:off x="6139669" y="2678857"/>
            <a:ext cx="17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gulation of Apoptos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1585A30D-480E-45F3-9316-C79B8FC3DF47}"/>
              </a:ext>
            </a:extLst>
          </p:cNvPr>
          <p:cNvSpPr txBox="1"/>
          <p:nvPr/>
        </p:nvSpPr>
        <p:spPr>
          <a:xfrm>
            <a:off x="6145890" y="3329158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edgehog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45C9DA5F-AB0F-4E97-8DA3-5D98C0DB8C24}"/>
              </a:ext>
            </a:extLst>
          </p:cNvPr>
          <p:cNvSpPr txBox="1"/>
          <p:nvPr/>
        </p:nvSpPr>
        <p:spPr>
          <a:xfrm>
            <a:off x="6160993" y="3941297"/>
            <a:ext cx="184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PK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D342170C-964F-4A6D-88AF-583D98C82FF5}"/>
              </a:ext>
            </a:extLst>
          </p:cNvPr>
          <p:cNvSpPr txBox="1"/>
          <p:nvPr/>
        </p:nvSpPr>
        <p:spPr>
          <a:xfrm>
            <a:off x="7891752" y="1225619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6BEB165-AAF3-4CD1-B1A9-80637C9AF6B1}"/>
              </a:ext>
            </a:extLst>
          </p:cNvPr>
          <p:cNvSpPr txBox="1"/>
          <p:nvPr/>
        </p:nvSpPr>
        <p:spPr>
          <a:xfrm>
            <a:off x="7590139" y="1333372"/>
            <a:ext cx="42687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5096F21-8D26-45AD-BB87-29A400ED7D28}"/>
              </a:ext>
            </a:extLst>
          </p:cNvPr>
          <p:cNvSpPr txBox="1"/>
          <p:nvPr/>
        </p:nvSpPr>
        <p:spPr>
          <a:xfrm>
            <a:off x="8167906" y="1596865"/>
            <a:ext cx="325730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7F5DEA6-A346-438C-AC8C-52137BB3917A}"/>
              </a:ext>
            </a:extLst>
          </p:cNvPr>
          <p:cNvSpPr txBox="1"/>
          <p:nvPr/>
        </p:nvSpPr>
        <p:spPr>
          <a:xfrm>
            <a:off x="338101" y="67611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2D2D315-7BD0-438B-90B2-5137EF051FBA}"/>
              </a:ext>
            </a:extLst>
          </p:cNvPr>
          <p:cNvSpPr txBox="1"/>
          <p:nvPr/>
        </p:nvSpPr>
        <p:spPr>
          <a:xfrm>
            <a:off x="338101" y="4792421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20D4D277-148E-4408-8EEA-6D5640CF79FF}"/>
              </a:ext>
            </a:extLst>
          </p:cNvPr>
          <p:cNvSpPr txBox="1"/>
          <p:nvPr/>
        </p:nvSpPr>
        <p:spPr>
          <a:xfrm>
            <a:off x="346577" y="89640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2E59CF67-CB76-4B7E-8F0B-208F19EE2DFA}"/>
              </a:ext>
            </a:extLst>
          </p:cNvPr>
          <p:cNvSpPr txBox="1"/>
          <p:nvPr/>
        </p:nvSpPr>
        <p:spPr>
          <a:xfrm>
            <a:off x="346577" y="1303741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994D8AF-07E9-47EF-B829-C3BA4DA707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821" y="990766"/>
            <a:ext cx="5400000" cy="3457253"/>
          </a:xfrm>
          <a:prstGeom prst="rect">
            <a:avLst/>
          </a:prstGeom>
        </p:spPr>
      </p:pic>
      <p:pic>
        <p:nvPicPr>
          <p:cNvPr id="102" name="图片 101">
            <a:extLst>
              <a:ext uri="{FF2B5EF4-FFF2-40B4-BE49-F238E27FC236}">
                <a16:creationId xmlns:a16="http://schemas.microsoft.com/office/drawing/2014/main" id="{4F98DEFC-CD0C-4BF0-8B7F-9470EC7B4C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7299" y="5238081"/>
            <a:ext cx="154647" cy="1283253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id="{2CD861C0-568B-424D-85C6-FBF14E18EB4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1333" y="5715301"/>
            <a:ext cx="139551" cy="538731"/>
          </a:xfrm>
          <a:prstGeom prst="rect">
            <a:avLst/>
          </a:prstGeom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E2FE12A2-52C7-412D-916A-F848E0C89178}"/>
              </a:ext>
            </a:extLst>
          </p:cNvPr>
          <p:cNvSpPr txBox="1"/>
          <p:nvPr/>
        </p:nvSpPr>
        <p:spPr>
          <a:xfrm>
            <a:off x="6092615" y="5095454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6FCCA1CA-3B6B-4015-B824-8C15F122BA35}"/>
              </a:ext>
            </a:extLst>
          </p:cNvPr>
          <p:cNvSpPr txBox="1"/>
          <p:nvPr/>
        </p:nvSpPr>
        <p:spPr>
          <a:xfrm>
            <a:off x="6087371" y="5515123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Mig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1E89AF45-29E1-488E-B7A6-803281F87BD8}"/>
              </a:ext>
            </a:extLst>
          </p:cNvPr>
          <p:cNvSpPr txBox="1"/>
          <p:nvPr/>
        </p:nvSpPr>
        <p:spPr>
          <a:xfrm>
            <a:off x="6120200" y="6202783"/>
            <a:ext cx="130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Prolife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8CD2B94D-AE68-447D-8292-CDAB69BF934F}"/>
              </a:ext>
            </a:extLst>
          </p:cNvPr>
          <p:cNvSpPr txBox="1"/>
          <p:nvPr/>
        </p:nvSpPr>
        <p:spPr>
          <a:xfrm>
            <a:off x="6139669" y="6816989"/>
            <a:ext cx="17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gulation of Apoptos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50653045-CE11-45FC-8611-BE25FF942C73}"/>
              </a:ext>
            </a:extLst>
          </p:cNvPr>
          <p:cNvSpPr txBox="1"/>
          <p:nvPr/>
        </p:nvSpPr>
        <p:spPr>
          <a:xfrm>
            <a:off x="6145890" y="7467290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edgehog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517F3977-E3C5-49B3-8AA8-EF18BFD7E98B}"/>
              </a:ext>
            </a:extLst>
          </p:cNvPr>
          <p:cNvSpPr txBox="1"/>
          <p:nvPr/>
        </p:nvSpPr>
        <p:spPr>
          <a:xfrm>
            <a:off x="6160993" y="8060379"/>
            <a:ext cx="184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PK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CB8D9B7B-E9BE-4A8E-9962-422E9F0BB2F1}"/>
              </a:ext>
            </a:extLst>
          </p:cNvPr>
          <p:cNvSpPr txBox="1"/>
          <p:nvPr/>
        </p:nvSpPr>
        <p:spPr>
          <a:xfrm>
            <a:off x="7891752" y="5306601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DDFE59AE-A435-45C7-AE1B-44646CB12002}"/>
              </a:ext>
            </a:extLst>
          </p:cNvPr>
          <p:cNvSpPr txBox="1"/>
          <p:nvPr/>
        </p:nvSpPr>
        <p:spPr>
          <a:xfrm>
            <a:off x="7590139" y="5414354"/>
            <a:ext cx="42687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FBFF8527-25B1-4579-A11C-76D822672826}"/>
              </a:ext>
            </a:extLst>
          </p:cNvPr>
          <p:cNvSpPr txBox="1"/>
          <p:nvPr/>
        </p:nvSpPr>
        <p:spPr>
          <a:xfrm>
            <a:off x="8167906" y="5677847"/>
            <a:ext cx="298480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13EA4DFC-8AD2-4EF1-B680-C8FD489CDB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9539" y="9435818"/>
            <a:ext cx="154647" cy="1283253"/>
          </a:xfrm>
          <a:prstGeom prst="rect">
            <a:avLst/>
          </a:prstGeom>
        </p:spPr>
      </p:pic>
      <p:pic>
        <p:nvPicPr>
          <p:cNvPr id="115" name="图片 114">
            <a:extLst>
              <a:ext uri="{FF2B5EF4-FFF2-40B4-BE49-F238E27FC236}">
                <a16:creationId xmlns:a16="http://schemas.microsoft.com/office/drawing/2014/main" id="{17FF0569-23F1-41CE-84E3-D07D0ED975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3573" y="9913038"/>
            <a:ext cx="139551" cy="538731"/>
          </a:xfrm>
          <a:prstGeom prst="rect">
            <a:avLst/>
          </a:prstGeom>
        </p:spPr>
      </p:pic>
      <p:sp>
        <p:nvSpPr>
          <p:cNvPr id="116" name="文本框 115">
            <a:extLst>
              <a:ext uri="{FF2B5EF4-FFF2-40B4-BE49-F238E27FC236}">
                <a16:creationId xmlns:a16="http://schemas.microsoft.com/office/drawing/2014/main" id="{180DBB31-47E6-41D1-938A-BF41AA79F66B}"/>
              </a:ext>
            </a:extLst>
          </p:cNvPr>
          <p:cNvSpPr txBox="1"/>
          <p:nvPr/>
        </p:nvSpPr>
        <p:spPr>
          <a:xfrm>
            <a:off x="6114855" y="9293191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864F4D2-20A6-4B44-A4B6-62AE06C114DA}"/>
              </a:ext>
            </a:extLst>
          </p:cNvPr>
          <p:cNvSpPr txBox="1"/>
          <p:nvPr/>
        </p:nvSpPr>
        <p:spPr>
          <a:xfrm>
            <a:off x="6109611" y="9712860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Mig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79C7B174-089E-4A4C-B7DC-6371B81065C6}"/>
              </a:ext>
            </a:extLst>
          </p:cNvPr>
          <p:cNvSpPr txBox="1"/>
          <p:nvPr/>
        </p:nvSpPr>
        <p:spPr>
          <a:xfrm>
            <a:off x="6142440" y="10382376"/>
            <a:ext cx="130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Prolife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8580FFCA-D927-4B37-8404-DC9BB38CD2B2}"/>
              </a:ext>
            </a:extLst>
          </p:cNvPr>
          <p:cNvSpPr txBox="1"/>
          <p:nvPr/>
        </p:nvSpPr>
        <p:spPr>
          <a:xfrm>
            <a:off x="6161909" y="11030146"/>
            <a:ext cx="17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gulation of Apoptos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54601856-095A-4CFC-AF5E-1B6D80BF2A29}"/>
              </a:ext>
            </a:extLst>
          </p:cNvPr>
          <p:cNvSpPr txBox="1"/>
          <p:nvPr/>
        </p:nvSpPr>
        <p:spPr>
          <a:xfrm>
            <a:off x="6168130" y="11680447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edgehog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6D4A008-DD17-4770-ACEB-54F59FEEDF4A}"/>
              </a:ext>
            </a:extLst>
          </p:cNvPr>
          <p:cNvSpPr txBox="1"/>
          <p:nvPr/>
        </p:nvSpPr>
        <p:spPr>
          <a:xfrm>
            <a:off x="6183233" y="12292586"/>
            <a:ext cx="184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PK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F78AB956-AAB9-47DA-933B-A3FD235C60F7}"/>
              </a:ext>
            </a:extLst>
          </p:cNvPr>
          <p:cNvSpPr txBox="1"/>
          <p:nvPr/>
        </p:nvSpPr>
        <p:spPr>
          <a:xfrm>
            <a:off x="7913992" y="9504338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425E450B-14E6-4A4E-A9CD-529995FCC52D}"/>
              </a:ext>
            </a:extLst>
          </p:cNvPr>
          <p:cNvSpPr txBox="1"/>
          <p:nvPr/>
        </p:nvSpPr>
        <p:spPr>
          <a:xfrm>
            <a:off x="7612379" y="9612091"/>
            <a:ext cx="42687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BD7E508B-4639-4FFA-AD7A-FBF2092267CB}"/>
              </a:ext>
            </a:extLst>
          </p:cNvPr>
          <p:cNvSpPr txBox="1"/>
          <p:nvPr/>
        </p:nvSpPr>
        <p:spPr>
          <a:xfrm>
            <a:off x="8190146" y="9875584"/>
            <a:ext cx="325730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6" name="图片 125">
            <a:extLst>
              <a:ext uri="{FF2B5EF4-FFF2-40B4-BE49-F238E27FC236}">
                <a16:creationId xmlns:a16="http://schemas.microsoft.com/office/drawing/2014/main" id="{7DB42B0E-4277-4EB1-80F8-E05BB05EBC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8711" y="13523066"/>
            <a:ext cx="154647" cy="1283253"/>
          </a:xfrm>
          <a:prstGeom prst="rect">
            <a:avLst/>
          </a:prstGeom>
        </p:spPr>
      </p:pic>
      <p:pic>
        <p:nvPicPr>
          <p:cNvPr id="127" name="图片 126">
            <a:extLst>
              <a:ext uri="{FF2B5EF4-FFF2-40B4-BE49-F238E27FC236}">
                <a16:creationId xmlns:a16="http://schemas.microsoft.com/office/drawing/2014/main" id="{D2924F2D-45D1-4ED1-80AA-1454BADCEC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2745" y="14000286"/>
            <a:ext cx="139551" cy="538731"/>
          </a:xfrm>
          <a:prstGeom prst="rect">
            <a:avLst/>
          </a:prstGeom>
        </p:spPr>
      </p:pic>
      <p:sp>
        <p:nvSpPr>
          <p:cNvPr id="128" name="文本框 127">
            <a:extLst>
              <a:ext uri="{FF2B5EF4-FFF2-40B4-BE49-F238E27FC236}">
                <a16:creationId xmlns:a16="http://schemas.microsoft.com/office/drawing/2014/main" id="{273DACC2-DF5D-43C0-8342-24F4B8786C86}"/>
              </a:ext>
            </a:extLst>
          </p:cNvPr>
          <p:cNvSpPr txBox="1"/>
          <p:nvPr/>
        </p:nvSpPr>
        <p:spPr>
          <a:xfrm>
            <a:off x="6144027" y="13380439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55B3FA06-636C-4DE5-B368-28751441DE3B}"/>
              </a:ext>
            </a:extLst>
          </p:cNvPr>
          <p:cNvSpPr txBox="1"/>
          <p:nvPr/>
        </p:nvSpPr>
        <p:spPr>
          <a:xfrm>
            <a:off x="6138783" y="13800108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Mig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E6DA633D-AA19-437D-8C64-3D94910ED3E4}"/>
              </a:ext>
            </a:extLst>
          </p:cNvPr>
          <p:cNvSpPr txBox="1"/>
          <p:nvPr/>
        </p:nvSpPr>
        <p:spPr>
          <a:xfrm>
            <a:off x="6171612" y="14440596"/>
            <a:ext cx="1308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 Prolifera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C2BC0DD4-0169-43DC-B767-05258C259280}"/>
              </a:ext>
            </a:extLst>
          </p:cNvPr>
          <p:cNvSpPr txBox="1"/>
          <p:nvPr/>
        </p:nvSpPr>
        <p:spPr>
          <a:xfrm>
            <a:off x="6191081" y="15102880"/>
            <a:ext cx="1795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gulation of Apoptos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09145419-F51F-47BB-AE97-55FEF3E7F586}"/>
              </a:ext>
            </a:extLst>
          </p:cNvPr>
          <p:cNvSpPr txBox="1"/>
          <p:nvPr/>
        </p:nvSpPr>
        <p:spPr>
          <a:xfrm>
            <a:off x="6197302" y="15753181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edgehog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ABA55B1C-4768-49AF-A038-4D9F0D9CAF8B}"/>
              </a:ext>
            </a:extLst>
          </p:cNvPr>
          <p:cNvSpPr txBox="1"/>
          <p:nvPr/>
        </p:nvSpPr>
        <p:spPr>
          <a:xfrm>
            <a:off x="6212405" y="16394348"/>
            <a:ext cx="1840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APK Signaling(KEGG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ED863026-656B-4B6D-88A4-6AFF9662062E}"/>
              </a:ext>
            </a:extLst>
          </p:cNvPr>
          <p:cNvSpPr txBox="1"/>
          <p:nvPr/>
        </p:nvSpPr>
        <p:spPr>
          <a:xfrm>
            <a:off x="7943164" y="13591586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EGF10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6BEAF4EF-1CE7-444F-B3FD-1063BE66848D}"/>
              </a:ext>
            </a:extLst>
          </p:cNvPr>
          <p:cNvSpPr txBox="1"/>
          <p:nvPr/>
        </p:nvSpPr>
        <p:spPr>
          <a:xfrm>
            <a:off x="7641551" y="13699339"/>
            <a:ext cx="42687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0A9B7897-1DFF-4264-970F-84356B7F9ABD}"/>
              </a:ext>
            </a:extLst>
          </p:cNvPr>
          <p:cNvSpPr txBox="1"/>
          <p:nvPr/>
        </p:nvSpPr>
        <p:spPr>
          <a:xfrm>
            <a:off x="8219318" y="13962832"/>
            <a:ext cx="325730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C7E353C5-A169-434C-A042-B20256972CF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890" y="5109867"/>
            <a:ext cx="5400000" cy="345725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4C8CC61-451F-4B35-A5DF-7E68D56D36F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83" y="9315181"/>
            <a:ext cx="5400000" cy="345725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FAE9174-8585-4D5E-A9D9-66FE1EC24A5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8130" y="13396929"/>
            <a:ext cx="5400000" cy="3457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0233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8</TotalTime>
  <Words>109</Words>
  <Application>Microsoft Office PowerPoint</Application>
  <PresentationFormat>自定义</PresentationFormat>
  <Paragraphs>6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i li</dc:creator>
  <cp:lastModifiedBy>si li</cp:lastModifiedBy>
  <cp:revision>14</cp:revision>
  <dcterms:created xsi:type="dcterms:W3CDTF">2018-04-19T03:25:52Z</dcterms:created>
  <dcterms:modified xsi:type="dcterms:W3CDTF">2018-04-19T15:40:05Z</dcterms:modified>
</cp:coreProperties>
</file>